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17" r:id="rId2"/>
    <p:sldId id="269" r:id="rId3"/>
    <p:sldId id="515" r:id="rId4"/>
    <p:sldId id="503" r:id="rId5"/>
    <p:sldId id="521" r:id="rId6"/>
    <p:sldId id="51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7 days under specified storage conditions </a:t>
            </a:r>
          </a:p>
        </c:rich>
      </c:tx>
      <c:layout>
        <c:manualLayout>
          <c:xMode val="edge"/>
          <c:yMode val="edge"/>
          <c:x val="0.26890966754155732"/>
          <c:y val="4.335260115606936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956-4BDE-BE10-17AB1B897B0F}"/>
              </c:ext>
            </c:extLst>
          </c:dPt>
          <c:dPt>
            <c:idx val="2"/>
            <c:invertIfNegative val="0"/>
            <c:bubble3D val="0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956-4BDE-BE10-17AB1B897B0F}"/>
              </c:ext>
            </c:extLst>
          </c:dPt>
          <c:dPt>
            <c:idx val="3"/>
            <c:invertIfNegative val="0"/>
            <c:bubble3D val="0"/>
            <c:spPr>
              <a:noFill/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956-4BDE-BE10-17AB1B897B0F}"/>
              </c:ext>
            </c:extLst>
          </c:dPt>
          <c:errBars>
            <c:errBarType val="both"/>
            <c:errValType val="cust"/>
            <c:noEndCap val="0"/>
            <c:plus>
              <c:numRef>
                <c:f>'2-10-2022'!$S$26:$S$29</c:f>
                <c:numCache>
                  <c:formatCode>General</c:formatCode>
                  <c:ptCount val="4"/>
                  <c:pt idx="0">
                    <c:v>2.7641680484369977</c:v>
                  </c:pt>
                  <c:pt idx="1">
                    <c:v>1.0043849174992601</c:v>
                  </c:pt>
                  <c:pt idx="2">
                    <c:v>5.365665343956266</c:v>
                  </c:pt>
                  <c:pt idx="3">
                    <c:v>6.1361770892660292</c:v>
                  </c:pt>
                </c:numCache>
              </c:numRef>
            </c:plus>
            <c:minus>
              <c:numRef>
                <c:f>'2-10-2022'!$S$26:$S$29</c:f>
                <c:numCache>
                  <c:formatCode>General</c:formatCode>
                  <c:ptCount val="4"/>
                  <c:pt idx="0">
                    <c:v>2.7641680484369977</c:v>
                  </c:pt>
                  <c:pt idx="1">
                    <c:v>1.0043849174992601</c:v>
                  </c:pt>
                  <c:pt idx="2">
                    <c:v>5.365665343956266</c:v>
                  </c:pt>
                  <c:pt idx="3">
                    <c:v>6.13617708926602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-10-2022'!$K$26:$K$29</c:f>
              <c:strCache>
                <c:ptCount val="4"/>
                <c:pt idx="0">
                  <c:v>Control 4°C</c:v>
                </c:pt>
                <c:pt idx="1">
                  <c:v>Control at 37°C</c:v>
                </c:pt>
                <c:pt idx="2">
                  <c:v>1mM Asc + 5 µM Cu/37°C</c:v>
                </c:pt>
                <c:pt idx="3">
                  <c:v>1 mM Asc + 10 µM Cu/37°C</c:v>
                </c:pt>
              </c:strCache>
            </c:strRef>
          </c:cat>
          <c:val>
            <c:numRef>
              <c:f>'2-10-2022'!$R$26:$R$29</c:f>
              <c:numCache>
                <c:formatCode>General</c:formatCode>
                <c:ptCount val="4"/>
                <c:pt idx="0">
                  <c:v>85.21875</c:v>
                </c:pt>
                <c:pt idx="1">
                  <c:v>48.281249999999993</c:v>
                </c:pt>
                <c:pt idx="2">
                  <c:v>17.041666666666668</c:v>
                </c:pt>
                <c:pt idx="3">
                  <c:v>13.82291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B3B-4AF5-863A-3AF720AC4F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5172400"/>
        <c:axId val="445185192"/>
      </c:barChart>
      <c:catAx>
        <c:axId val="445172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5185192"/>
        <c:crosses val="autoZero"/>
        <c:auto val="1"/>
        <c:lblAlgn val="ctr"/>
        <c:lblOffset val="100"/>
        <c:noMultiLvlLbl val="0"/>
      </c:catAx>
      <c:valAx>
        <c:axId val="4451851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FA/µ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5172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3 days under specified storage condition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DBA-4A84-AEF3-24F4548253A7}"/>
              </c:ext>
            </c:extLst>
          </c:dPt>
          <c:dPt>
            <c:idx val="1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DBA-4A84-AEF3-24F4548253A7}"/>
              </c:ext>
            </c:extLst>
          </c:dPt>
          <c:dPt>
            <c:idx val="2"/>
            <c:invertIfNegative val="0"/>
            <c:bubble3D val="0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DBA-4A84-AEF3-24F4548253A7}"/>
              </c:ext>
            </c:extLst>
          </c:dPt>
          <c:dPt>
            <c:idx val="3"/>
            <c:invertIfNegative val="0"/>
            <c:bubble3D val="0"/>
            <c:spPr>
              <a:noFill/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DBA-4A84-AEF3-24F4548253A7}"/>
              </c:ext>
            </c:extLst>
          </c:dPt>
          <c:errBars>
            <c:errBarType val="both"/>
            <c:errValType val="cust"/>
            <c:noEndCap val="0"/>
            <c:plus>
              <c:numRef>
                <c:f>'2-7-2022'!$S$26:$S$29</c:f>
                <c:numCache>
                  <c:formatCode>General</c:formatCode>
                  <c:ptCount val="4"/>
                  <c:pt idx="0">
                    <c:v>4.548311726531832</c:v>
                  </c:pt>
                  <c:pt idx="1">
                    <c:v>1.219908858886926</c:v>
                  </c:pt>
                  <c:pt idx="2">
                    <c:v>6.8948060621290468</c:v>
                  </c:pt>
                  <c:pt idx="3">
                    <c:v>1.5189119216088658</c:v>
                  </c:pt>
                </c:numCache>
              </c:numRef>
            </c:plus>
            <c:minus>
              <c:numRef>
                <c:f>'2-7-2022'!$S$26:$S$29</c:f>
                <c:numCache>
                  <c:formatCode>General</c:formatCode>
                  <c:ptCount val="4"/>
                  <c:pt idx="0">
                    <c:v>4.548311726531832</c:v>
                  </c:pt>
                  <c:pt idx="1">
                    <c:v>1.219908858886926</c:v>
                  </c:pt>
                  <c:pt idx="2">
                    <c:v>6.8948060621290468</c:v>
                  </c:pt>
                  <c:pt idx="3">
                    <c:v>1.51891192160886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-7-2022'!$K$26:$K$29</c:f>
              <c:strCache>
                <c:ptCount val="4"/>
                <c:pt idx="0">
                  <c:v>Control 4°C</c:v>
                </c:pt>
                <c:pt idx="1">
                  <c:v>Control at 37°C</c:v>
                </c:pt>
                <c:pt idx="2">
                  <c:v>1mM Asc + 5 µM Cu/37°C</c:v>
                </c:pt>
                <c:pt idx="3">
                  <c:v>1 mM Asc + 10 µM Cu/37°C</c:v>
                </c:pt>
              </c:strCache>
            </c:strRef>
          </c:cat>
          <c:val>
            <c:numRef>
              <c:f>'2-7-2022'!$R$26:$R$29</c:f>
              <c:numCache>
                <c:formatCode>General</c:formatCode>
                <c:ptCount val="4"/>
                <c:pt idx="0">
                  <c:v>93.01960784313728</c:v>
                </c:pt>
                <c:pt idx="1">
                  <c:v>66.009803921568633</c:v>
                </c:pt>
                <c:pt idx="2">
                  <c:v>37.166666666666664</c:v>
                </c:pt>
                <c:pt idx="3">
                  <c:v>35.764705882352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DBA-4A84-AEF3-24F4548253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5734608"/>
        <c:axId val="595738216"/>
      </c:barChart>
      <c:catAx>
        <c:axId val="595734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5738216"/>
        <c:crosses val="autoZero"/>
        <c:auto val="1"/>
        <c:lblAlgn val="ctr"/>
        <c:lblOffset val="100"/>
        <c:noMultiLvlLbl val="0"/>
      </c:catAx>
      <c:valAx>
        <c:axId val="5957382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FA/µ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5734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1 hour </a:t>
            </a:r>
            <a:r>
              <a:rPr lang="en-US" baseline="0" dirty="0"/>
              <a:t>under specified storage conditions</a:t>
            </a:r>
            <a:endParaRPr lang="en-US" dirty="0"/>
          </a:p>
        </c:rich>
      </c:tx>
      <c:layout>
        <c:manualLayout>
          <c:xMode val="edge"/>
          <c:yMode val="edge"/>
          <c:x val="0.13775678040244968"/>
          <c:y val="2.89855072463768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598-4887-986D-05205FB18CD0}"/>
              </c:ext>
            </c:extLst>
          </c:dPt>
          <c:dPt>
            <c:idx val="1"/>
            <c:invertIfNegative val="0"/>
            <c:bubble3D val="0"/>
            <c:spPr>
              <a:pattFill prst="wdDnDiag">
                <a:fgClr>
                  <a:schemeClr val="tx2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598-4887-986D-05205FB18CD0}"/>
              </c:ext>
            </c:extLst>
          </c:dPt>
          <c:dPt>
            <c:idx val="2"/>
            <c:invertIfNegative val="0"/>
            <c:bubble3D val="0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598-4887-986D-05205FB18CD0}"/>
              </c:ext>
            </c:extLst>
          </c:dPt>
          <c:dPt>
            <c:idx val="3"/>
            <c:invertIfNegative val="0"/>
            <c:bubble3D val="0"/>
            <c:spPr>
              <a:noFill/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598-4887-986D-05205FB18CD0}"/>
              </c:ext>
            </c:extLst>
          </c:dPt>
          <c:errBars>
            <c:errBarType val="both"/>
            <c:errValType val="cust"/>
            <c:noEndCap val="0"/>
            <c:plus>
              <c:numRef>
                <c:f>'2-4-2022'!$Y$38:$Y$41</c:f>
                <c:numCache>
                  <c:formatCode>General</c:formatCode>
                  <c:ptCount val="4"/>
                  <c:pt idx="0">
                    <c:v>2.5091576983493096</c:v>
                  </c:pt>
                  <c:pt idx="1">
                    <c:v>0.74775650110596648</c:v>
                  </c:pt>
                  <c:pt idx="2">
                    <c:v>3.7022834213610132</c:v>
                  </c:pt>
                  <c:pt idx="3">
                    <c:v>1.3735270229705723</c:v>
                  </c:pt>
                </c:numCache>
              </c:numRef>
            </c:plus>
            <c:minus>
              <c:numRef>
                <c:f>'2-4-2022'!$Y$38:$Y$41</c:f>
                <c:numCache>
                  <c:formatCode>General</c:formatCode>
                  <c:ptCount val="4"/>
                  <c:pt idx="0">
                    <c:v>2.5091576983493096</c:v>
                  </c:pt>
                  <c:pt idx="1">
                    <c:v>0.74775650110596648</c:v>
                  </c:pt>
                  <c:pt idx="2">
                    <c:v>3.7022834213610132</c:v>
                  </c:pt>
                  <c:pt idx="3">
                    <c:v>1.37352702297057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-4-2022'!$Q$38:$Q$41</c:f>
              <c:strCache>
                <c:ptCount val="4"/>
                <c:pt idx="0">
                  <c:v>Control 4°C</c:v>
                </c:pt>
                <c:pt idx="1">
                  <c:v>Control at 37°C</c:v>
                </c:pt>
                <c:pt idx="2">
                  <c:v>1mM Asc + 5 µM Cu/37°C</c:v>
                </c:pt>
                <c:pt idx="3">
                  <c:v>1 mM Asc + 10 µM Cu/37°C</c:v>
                </c:pt>
              </c:strCache>
            </c:strRef>
          </c:cat>
          <c:val>
            <c:numRef>
              <c:f>'2-4-2022'!$X$38:$X$41</c:f>
              <c:numCache>
                <c:formatCode>General</c:formatCode>
                <c:ptCount val="4"/>
                <c:pt idx="0">
                  <c:v>111.88172043010752</c:v>
                </c:pt>
                <c:pt idx="1">
                  <c:v>109.05376344086022</c:v>
                </c:pt>
                <c:pt idx="2">
                  <c:v>105.21505376344088</c:v>
                </c:pt>
                <c:pt idx="3">
                  <c:v>106.77419354838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598-4887-986D-05205FB18C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22893304"/>
        <c:axId val="722885760"/>
      </c:barChart>
      <c:catAx>
        <c:axId val="722893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2885760"/>
        <c:crosses val="autoZero"/>
        <c:auto val="1"/>
        <c:lblAlgn val="ctr"/>
        <c:lblOffset val="100"/>
        <c:noMultiLvlLbl val="0"/>
      </c:catAx>
      <c:valAx>
        <c:axId val="722885760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FA/µ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2893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DCD941-D0C6-4D0C-8C5C-890213DFA7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061725-2E29-449A-97D8-6D9E5B1791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8FD52-8ED8-467D-8D18-EB1D7036E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5819B9-4A0F-4506-A26E-318040353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0D394F-F8C6-4ECE-A4B8-0715079B2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010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B6F13-08CE-40DD-BAC3-608FB8D31B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D54198-6740-49C2-9E39-46E63EB35C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66A08-3413-4EF0-8895-FBF355FF7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262691-5572-4097-876A-A69698C20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8CA1F5-C0C8-47F5-B4A0-89C6747ED4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710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33A67F-2746-4CFA-B695-171A505F4E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4B42FA-4305-4AD8-B486-D81C805510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4C1CEF-AEF7-4576-8530-EA847345C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532765-CCE2-4B05-8BFB-EE05106E3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3F5272-D660-4535-92F7-EE5A4D2A4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567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CD6F0-811F-4A40-B45B-E994B00FF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BC13CB-96AB-4099-A788-B0002CE426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9B2CA6-E882-456D-B65A-B3EFBFAE3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97120A-4F8E-404B-93E5-028192597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FC7664-6580-4B98-8D4C-4A2EC345E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751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D5CBB9-4B60-4FDC-B81C-42CB0D495A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7B8B01-DE9E-40EF-82F7-E425891021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612008-FAEC-4E2C-AE6D-1F5430817B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FADECC-714B-4726-94A3-632FFAB6D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059A99-C51E-482D-AAA5-D0D0A832E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8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BFDEAF-2AD1-4DC8-8E2F-7166E075F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B61500-6334-4C0A-AC13-859C12157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C3AE75-9B07-4532-A1AF-288651088C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2EBE1F-A37E-4F1B-B364-7125964DC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59148D-EC41-4EBB-8DDA-2D7082B07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B7EFD4-A766-49A4-9C29-B5849EDA6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089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A14C55-4CB2-4B35-8DFC-9F4B4BA839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94C6EE-66DA-4EF7-85B5-D5FCD05682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0FF7A9-24C7-405C-8B28-7A3F56F7C1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3D70FB-648F-42D1-898D-566CF1635A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BFA14A-798C-4C6D-A07E-40C4EBE4DC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DC2F34-4728-47C1-96EE-D67E7F75D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64FABD9-FCA1-4520-8962-5DAB3ABDB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8F6C85-D33B-4131-9B70-F082CD204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277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C95E1-8557-4619-84F4-406007C354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09D643-B129-42A3-A95E-38C091FF4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A22E6A-4CED-4A73-8D34-F285F8BFB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248CED-5CEE-425E-9E2F-A51D569EB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515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F68ACDA-04A8-4A9D-8C3A-63A5342F2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A8D601-524A-4671-B2E1-4FC298447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055FD0-A701-407C-9492-4523703D2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35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102355-4A53-423F-AEC3-724DF6B031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CC9AA4-5B51-46D1-B9A3-A480BDF1A8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E65AEE-B6BD-432D-B5BA-E4292D2C3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9B6170-9217-4813-849D-891D2200B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B3D188-7261-4B38-9F1B-1520732B8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64331B-3789-4521-AC69-4C11E30F1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821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D9DF4F-C1DE-4779-9FA1-98B8C23297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E9A7B8-73AA-4EC5-84E7-125E371580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24FB2C-CD24-4EA9-859D-4F34DD4A41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B19AFF-AEBD-4DB0-B6FE-0E34F1A33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960412-A8B5-43EA-8A4C-C8A2F9967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EAE941-1B50-4529-B066-085D1277A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713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624673C-F666-49D6-AA39-069E9CFDA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E1511A-FE02-40A7-814B-D6A58B1E63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47CDEB-8601-4576-8692-585EC1BB41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F8B21-524D-4D88-A9D6-C687CB74FEE1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3C21EE-E47B-458E-B314-0C1382503E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1C7C3D-74B2-43ED-B290-A98CAA1E23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E848C-38AA-486E-B2EB-B9CA085F9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191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emf"/><Relationship Id="rId5" Type="http://schemas.openxmlformats.org/officeDocument/2006/relationships/package" Target="../embeddings/Microsoft_Excel_Worksheet4.xlsx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B608086-3401-EC7E-AC7F-E35CFDD0081D}"/>
              </a:ext>
            </a:extLst>
          </p:cNvPr>
          <p:cNvSpPr txBox="1"/>
          <p:nvPr/>
        </p:nvSpPr>
        <p:spPr>
          <a:xfrm>
            <a:off x="4030980" y="2316480"/>
            <a:ext cx="279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s and </a:t>
            </a:r>
          </a:p>
        </p:txBody>
      </p:sp>
    </p:spTree>
    <p:extLst>
      <p:ext uri="{BB962C8B-B14F-4D97-AF65-F5344CB8AC3E}">
        <p14:creationId xmlns:p14="http://schemas.microsoft.com/office/powerpoint/2010/main" val="4282042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1066AB9-A7E8-4DA6-A98B-9D6B95823A62}"/>
              </a:ext>
            </a:extLst>
          </p:cNvPr>
          <p:cNvSpPr txBox="1"/>
          <p:nvPr/>
        </p:nvSpPr>
        <p:spPr>
          <a:xfrm>
            <a:off x="525481" y="4437759"/>
            <a:ext cx="103550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. S1 </a:t>
            </a:r>
            <a:r>
              <a:rPr lang="en-US" sz="1400" dirty="0"/>
              <a:t>Optimization of enzyme concentration for release of FFA from PS20 using Bevacizumab formulation containing PS20 NF. Bevacizumab formulation containing 0.04% PS20 NF was treated with (A) lipase at concentrations of 0, 12.5 U/mL, 25 U/mL, 50 U/mL, 125 U/mL, 250U/mL, and 500 U/mL and  (B) Esterase  at concentration of 0, 0.5 U/mL, 1U/mL, and 2U/mL and FFA level was monitored at 0, 0.83, 0.33, 5, 12 and 21 days.  1U esterase corresponds to 4.8 µg esterase and 250 U lipase corresponds to 5 µg lipase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578A960-43B3-4D72-89C6-3ADF1AC719A5}"/>
              </a:ext>
            </a:extLst>
          </p:cNvPr>
          <p:cNvSpPr txBox="1"/>
          <p:nvPr/>
        </p:nvSpPr>
        <p:spPr>
          <a:xfrm>
            <a:off x="525481" y="66012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96AEE1-2493-4513-BAFD-47A79CFD8D33}"/>
              </a:ext>
            </a:extLst>
          </p:cNvPr>
          <p:cNvSpPr txBox="1"/>
          <p:nvPr/>
        </p:nvSpPr>
        <p:spPr>
          <a:xfrm>
            <a:off x="6037482" y="69526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6E42063-BB2B-40A2-9471-11657BA0F7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9824821"/>
              </p:ext>
            </p:extLst>
          </p:nvPr>
        </p:nvGraphicFramePr>
        <p:xfrm>
          <a:off x="188978" y="849152"/>
          <a:ext cx="5040313" cy="3284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3" imgW="5040099" imgH="3284245" progId="Prism6.Document">
                  <p:embed/>
                </p:oleObj>
              </mc:Choice>
              <mc:Fallback>
                <p:oleObj name="Prism 6" r:id="rId3" imgW="5040099" imgH="328424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978" y="849152"/>
                        <a:ext cx="5040313" cy="3284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2A9943FB-FA89-44B0-8FEA-7D0604096A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8534517"/>
              </p:ext>
            </p:extLst>
          </p:nvPr>
        </p:nvGraphicFramePr>
        <p:xfrm>
          <a:off x="5795926" y="1096802"/>
          <a:ext cx="4592637" cy="3036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6" r:id="rId5" imgW="4592090" imgH="3037179" progId="Prism6.Document">
                  <p:embed/>
                </p:oleObj>
              </mc:Choice>
              <mc:Fallback>
                <p:oleObj name="Prism 6" r:id="rId5" imgW="4592090" imgH="303717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95926" y="1096802"/>
                        <a:ext cx="4592637" cy="3036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86638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374B6EA-FBAC-E3E2-CBCA-50134DF26967}"/>
              </a:ext>
            </a:extLst>
          </p:cNvPr>
          <p:cNvSpPr txBox="1"/>
          <p:nvPr/>
        </p:nvSpPr>
        <p:spPr>
          <a:xfrm>
            <a:off x="228507" y="4850984"/>
            <a:ext cx="1055973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. S2 </a:t>
            </a:r>
            <a:r>
              <a:rPr lang="en-US" sz="1400" dirty="0"/>
              <a:t>Comparison of pH dependent formation of subvisible particles at 4°C and 37°C. Formulation buffers containing same excipients with 0.02% PS20 NF at pH 5.6, 6.8 and 7.6 were and treated with 1U/mL esterase at 4°C and 37°C. The formation of total number of particles were compared at 4°C and 37°C after 4 weeks (A). Particles were analyzed at 37°C (B). Subvisible particles were determined using MFI  E = esterase, L = Lipase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257140CB-4A14-6392-C89B-6A7EFDA440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0372995"/>
              </p:ext>
            </p:extLst>
          </p:nvPr>
        </p:nvGraphicFramePr>
        <p:xfrm>
          <a:off x="966093" y="1075285"/>
          <a:ext cx="4400550" cy="3868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6" r:id="rId3" imgW="4399778" imgH="3868054" progId="Prism6.Document">
                  <p:embed/>
                </p:oleObj>
              </mc:Choice>
              <mc:Fallback>
                <p:oleObj name="Prism 6" r:id="rId3" imgW="4399778" imgH="386805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66093" y="1075285"/>
                        <a:ext cx="4400550" cy="3868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21FEA299-60E0-A514-FF2F-ACECE21BAB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1784800"/>
              </p:ext>
            </p:extLst>
          </p:nvPr>
        </p:nvGraphicFramePr>
        <p:xfrm>
          <a:off x="5882936" y="1396891"/>
          <a:ext cx="4033421" cy="34292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6" r:id="rId5" imgW="3604238" imgH="3063110" progId="Prism6.Document">
                  <p:embed/>
                </p:oleObj>
              </mc:Choice>
              <mc:Fallback>
                <p:oleObj name="Prism 6" r:id="rId5" imgW="3604238" imgH="306311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82936" y="1396891"/>
                        <a:ext cx="4033421" cy="34292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F0D7697-E25A-9830-DDA7-BC2B9C104071}"/>
              </a:ext>
            </a:extLst>
          </p:cNvPr>
          <p:cNvSpPr txBox="1"/>
          <p:nvPr/>
        </p:nvSpPr>
        <p:spPr>
          <a:xfrm>
            <a:off x="1145219" y="79899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623652-BC04-F611-A177-9727637DE4EC}"/>
              </a:ext>
            </a:extLst>
          </p:cNvPr>
          <p:cNvSpPr txBox="1"/>
          <p:nvPr/>
        </p:nvSpPr>
        <p:spPr>
          <a:xfrm>
            <a:off x="5873411" y="83049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663052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B3AE63-C9C1-4AE6-BA21-32F1911BE8D8}"/>
              </a:ext>
            </a:extLst>
          </p:cNvPr>
          <p:cNvSpPr txBox="1"/>
          <p:nvPr/>
        </p:nvSpPr>
        <p:spPr>
          <a:xfrm>
            <a:off x="228284" y="5590353"/>
            <a:ext cx="1060190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. S3 </a:t>
            </a:r>
            <a:r>
              <a:rPr lang="en-US" sz="1400" dirty="0"/>
              <a:t>NEFA kit and limitations to detect oxidized FFA. The standard used in NEFA kit (oleic acid) was subjected to oxidation by treatment with ascorbic acid and Cu</a:t>
            </a:r>
            <a:r>
              <a:rPr lang="en-US" sz="1400" baseline="30000" dirty="0"/>
              <a:t>2+ </a:t>
            </a:r>
            <a:r>
              <a:rPr lang="en-US" sz="1400" dirty="0"/>
              <a:t>and incubated at 37°C for 7 days. FFA concentration was determined at 1 hour (A), 3 days (B),  and 7 days (C) using NEFA kit. Sample incubated at 4°C was used as a control to monitor oleic acid concentration over time.   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CA6B48C8-F2F8-494E-ADAB-F6ACD88DB3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4477199"/>
              </p:ext>
            </p:extLst>
          </p:nvPr>
        </p:nvGraphicFramePr>
        <p:xfrm>
          <a:off x="391432" y="2796350"/>
          <a:ext cx="4572000" cy="2636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1A13344B-6470-4738-BB0A-3C516FE544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5224602"/>
              </p:ext>
            </p:extLst>
          </p:nvPr>
        </p:nvGraphicFramePr>
        <p:xfrm>
          <a:off x="5342890" y="105145"/>
          <a:ext cx="4572000" cy="2636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7EAFA840-F8F7-4A2E-8EDB-70A6441633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9865203"/>
              </p:ext>
            </p:extLst>
          </p:nvPr>
        </p:nvGraphicFramePr>
        <p:xfrm>
          <a:off x="391432" y="112765"/>
          <a:ext cx="4572000" cy="2628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9A92E7F-2E34-4E66-B114-1C8C986CAF68}"/>
              </a:ext>
            </a:extLst>
          </p:cNvPr>
          <p:cNvSpPr txBox="1"/>
          <p:nvPr/>
        </p:nvSpPr>
        <p:spPr>
          <a:xfrm>
            <a:off x="319790" y="10514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3A012B8-3235-4F3C-95EE-496D72F6ADA3}"/>
              </a:ext>
            </a:extLst>
          </p:cNvPr>
          <p:cNvSpPr txBox="1"/>
          <p:nvPr/>
        </p:nvSpPr>
        <p:spPr>
          <a:xfrm>
            <a:off x="5342890" y="19344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791749-B54B-4AC5-BA97-52A6AF13D69F}"/>
              </a:ext>
            </a:extLst>
          </p:cNvPr>
          <p:cNvSpPr txBox="1"/>
          <p:nvPr/>
        </p:nvSpPr>
        <p:spPr>
          <a:xfrm>
            <a:off x="478648" y="295383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473704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FDF6928F-1A37-ED13-5F43-3A9D6C4F2D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8774" y="199383"/>
            <a:ext cx="6623304" cy="504748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1487D37-4A77-1ADB-11E9-DE556166BDB7}"/>
              </a:ext>
            </a:extLst>
          </p:cNvPr>
          <p:cNvSpPr txBox="1"/>
          <p:nvPr/>
        </p:nvSpPr>
        <p:spPr>
          <a:xfrm>
            <a:off x="825695" y="5315784"/>
            <a:ext cx="872097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ry Fig. S4. </a:t>
            </a:r>
            <a:r>
              <a:rPr lang="en-US" sz="1400" dirty="0"/>
              <a:t>Effect of PS20 degradation on the stability of therapeutic proteins and the formation of HMWs. Formulations prepared with therapeutic proteins were treated with 1 U/mL esterase or 250 U/mL lipase enzymes at 37°C for 4 weeks and analyzed by SEC-UPLC. Representative SEC-UPLC chromatograms for T-DM1 (A and B) and bevacizumab (C and D) with UV detection at 280 nm and 220 nm. E = esterase, L = Lipase</a:t>
            </a:r>
          </a:p>
        </p:txBody>
      </p:sp>
    </p:spTree>
    <p:extLst>
      <p:ext uri="{BB962C8B-B14F-4D97-AF65-F5344CB8AC3E}">
        <p14:creationId xmlns:p14="http://schemas.microsoft.com/office/powerpoint/2010/main" val="36381823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F6EDA29-7C90-BA8D-F7F2-A849972BF35B}"/>
              </a:ext>
            </a:extLst>
          </p:cNvPr>
          <p:cNvSpPr txBox="1"/>
          <p:nvPr/>
        </p:nvSpPr>
        <p:spPr>
          <a:xfrm>
            <a:off x="771788" y="107627"/>
            <a:ext cx="397638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Table S1</a:t>
            </a:r>
            <a:r>
              <a:rPr lang="en-US" sz="1400" dirty="0"/>
              <a:t>. Comparison of PS20 NF and PS20 SR degradation to form subvisible particles at 4°C in the presence of esterase or lipase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6C885C-F7C3-BE03-A48E-49FDDAD26CC1}"/>
              </a:ext>
            </a:extLst>
          </p:cNvPr>
          <p:cNvSpPr txBox="1"/>
          <p:nvPr/>
        </p:nvSpPr>
        <p:spPr>
          <a:xfrm>
            <a:off x="778429" y="3353778"/>
            <a:ext cx="431194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Table S2. </a:t>
            </a:r>
            <a:r>
              <a:rPr lang="en-US" sz="1400" dirty="0"/>
              <a:t>Comparison of PS20 NF and PS20 SR degradation to form subvisible particles at 37°C in the presence of esterase or lipase.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5054819A-DFA7-546D-40C8-F021C0A4D1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4756263"/>
              </p:ext>
            </p:extLst>
          </p:nvPr>
        </p:nvGraphicFramePr>
        <p:xfrm>
          <a:off x="887879" y="997629"/>
          <a:ext cx="2362200" cy="2384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Worksheet" r:id="rId3" imgW="2362129" imgH="2384878" progId="Excel.Sheet.12">
                  <p:embed/>
                </p:oleObj>
              </mc:Choice>
              <mc:Fallback>
                <p:oleObj name="Worksheet" r:id="rId3" imgW="2362129" imgH="238487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87879" y="997629"/>
                        <a:ext cx="2362200" cy="2384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1302345-2513-A579-6298-0BBDE7CCBD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323130"/>
              </p:ext>
            </p:extLst>
          </p:nvPr>
        </p:nvGraphicFramePr>
        <p:xfrm>
          <a:off x="887879" y="4064166"/>
          <a:ext cx="2338387" cy="2384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Worksheet" r:id="rId5" imgW="2339163" imgH="2384878" progId="Excel.Sheet.12">
                  <p:embed/>
                </p:oleObj>
              </mc:Choice>
              <mc:Fallback>
                <p:oleObj name="Worksheet" r:id="rId5" imgW="2339163" imgH="238487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87879" y="4064166"/>
                        <a:ext cx="2338387" cy="2384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4506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93</TotalTime>
  <Words>444</Words>
  <Application>Microsoft Office PowerPoint</Application>
  <PresentationFormat>Widescreen</PresentationFormat>
  <Paragraphs>20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6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yal, Baikuntha</dc:creator>
  <cp:lastModifiedBy>Catubig, Editha</cp:lastModifiedBy>
  <cp:revision>50</cp:revision>
  <dcterms:created xsi:type="dcterms:W3CDTF">2023-02-10T19:16:18Z</dcterms:created>
  <dcterms:modified xsi:type="dcterms:W3CDTF">2024-04-11T09:48:14Z</dcterms:modified>
</cp:coreProperties>
</file>